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FF5912-33A8-4433-B469-EE158A34C0C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C74AF8-6D27-4427-A100-D53D22D381B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8FCD49-1923-4AB6-BAD0-CA14E3AC31C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6B9F62-BD89-4777-846B-585DF4B7CA2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87A3F5-4A5E-45F2-8E2C-23E889E2743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9B3202-90E4-43E8-B3D5-702D055386A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8D56D2-0FDC-4797-ACB4-5971E55A4C9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1D4164-06AE-41D4-AA2C-8D2DAB87AB8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389E15-32B0-4986-88BF-1A3456D416C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99F085-C6D2-4060-A2DE-312991140B2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D3FB75-D783-418D-98B2-1F451163738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58A280-6DCB-4520-971E-A1739DBAA33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A4BF4204-81FA-45A7-A0C5-5BECBA85776B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wmf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subTitle"/>
          </p:nvPr>
        </p:nvSpPr>
        <p:spPr>
          <a:xfrm>
            <a:off x="1371600" y="3886200"/>
            <a:ext cx="6400800" cy="175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898989"/>
              </a:solidFill>
              <a:latin typeface="Calibri"/>
            </a:endParaRPr>
          </a:p>
        </p:txBody>
      </p:sp>
      <p:sp>
        <p:nvSpPr>
          <p:cNvPr id="42" name="Text Box 5"/>
          <p:cNvSpPr/>
          <p:nvPr/>
        </p:nvSpPr>
        <p:spPr>
          <a:xfrm>
            <a:off x="2673360" y="1347840"/>
            <a:ext cx="50990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Table S5: Statistical analysis of the effects of the combination drug treatment on the percentage of Ki67-positive acini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43" name="Object 62"/>
          <p:cNvGraphicFramePr/>
          <p:nvPr/>
        </p:nvGraphicFramePr>
        <p:xfrm>
          <a:off x="1273320" y="1751040"/>
          <a:ext cx="5952960" cy="198756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44" name="Object 62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273320" y="1751040"/>
                    <a:ext cx="5952960" cy="19875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2-01T22:20:20Z</dcterms:created>
  <dc:creator>Khandan Keyomarsi</dc:creator>
  <dc:description/>
  <dc:language>en-US</dc:language>
  <cp:lastModifiedBy>Khandan Keyomarsi</cp:lastModifiedBy>
  <dcterms:modified xsi:type="dcterms:W3CDTF">2012-02-01T22:21:00Z</dcterms:modified>
  <cp:revision>1</cp:revision>
  <dc:subject/>
  <dc:title>PowerPoint Presentation</dc:title>
</cp:coreProperties>
</file>